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1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36"/>
    <p:restoredTop sz="94631"/>
  </p:normalViewPr>
  <p:slideViewPr>
    <p:cSldViewPr snapToGrid="0" snapToObjects="1">
      <p:cViewPr>
        <p:scale>
          <a:sx n="176" d="100"/>
          <a:sy n="176" d="100"/>
        </p:scale>
        <p:origin x="168" y="-2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C4C760-06A5-DE44-B0B9-C7681A671F20}" type="datetimeFigureOut">
              <a:rPr lang="en-US" smtClean="0"/>
              <a:t>3/2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D3C8F-4F3F-1D45-9F41-19937EDA4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478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844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910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75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009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371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914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654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515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844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94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436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078DB-6F8E-4941-949C-8298A1D51DB3}" type="datetimeFigureOut">
              <a:rPr lang="en-US" smtClean="0"/>
              <a:t>3/2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611D1-6AAB-D64E-ACEF-1A316A531F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99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9392194-6C89-4245-8297-85EF2D49DE99}"/>
              </a:ext>
            </a:extLst>
          </p:cNvPr>
          <p:cNvSpPr txBox="1"/>
          <p:nvPr/>
        </p:nvSpPr>
        <p:spPr>
          <a:xfrm>
            <a:off x="1760928" y="332939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D831B2-0ED5-5C40-9E92-803B3543D909}"/>
              </a:ext>
            </a:extLst>
          </p:cNvPr>
          <p:cNvSpPr txBox="1"/>
          <p:nvPr/>
        </p:nvSpPr>
        <p:spPr>
          <a:xfrm>
            <a:off x="1782568" y="3670006"/>
            <a:ext cx="2183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067601-6F2E-5A46-9F19-B9262DD166F8}"/>
              </a:ext>
            </a:extLst>
          </p:cNvPr>
          <p:cNvSpPr txBox="1"/>
          <p:nvPr/>
        </p:nvSpPr>
        <p:spPr>
          <a:xfrm>
            <a:off x="1466083" y="4457483"/>
            <a:ext cx="4005327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Templates degradation by reaction buffer component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, circula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l, linea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STV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5CFB0F4-C1F5-F14F-8BA5-3A78AFB844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-2000"/>
                    </a14:imgEffect>
                    <a14:imgEffect>
                      <a14:brightnessContrast bright="10000" contrast="-38000"/>
                    </a14:imgEffect>
                  </a14:imgLayer>
                </a14:imgProps>
              </a:ext>
            </a:extLst>
          </a:blip>
          <a:srcRect l="13646" t="38117" r="44033" b="21060"/>
          <a:stretch/>
        </p:blipFill>
        <p:spPr>
          <a:xfrm flipH="1">
            <a:off x="2022537" y="3285285"/>
            <a:ext cx="2628975" cy="7846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405A9C7-61EC-C743-BF96-470043509C84}"/>
              </a:ext>
            </a:extLst>
          </p:cNvPr>
          <p:cNvSpPr txBox="1"/>
          <p:nvPr/>
        </p:nvSpPr>
        <p:spPr>
          <a:xfrm rot="18997007">
            <a:off x="1923411" y="2899090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dH2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B5DA587-E334-2B49-8638-A5E73A32C510}"/>
              </a:ext>
            </a:extLst>
          </p:cNvPr>
          <p:cNvSpPr txBox="1"/>
          <p:nvPr/>
        </p:nvSpPr>
        <p:spPr>
          <a:xfrm rot="18997007">
            <a:off x="2272929" y="2741088"/>
            <a:ext cx="1149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% Glyce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0AE37E-07A6-D14F-BE1B-E9F7CCA61AEF}"/>
              </a:ext>
            </a:extLst>
          </p:cNvPr>
          <p:cNvSpPr txBox="1"/>
          <p:nvPr/>
        </p:nvSpPr>
        <p:spPr>
          <a:xfrm rot="18997007">
            <a:off x="2649414" y="2579782"/>
            <a:ext cx="16193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HEPES-KO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ADD4F6-3AAD-1741-A303-AE9777ABBBF0}"/>
              </a:ext>
            </a:extLst>
          </p:cNvPr>
          <p:cNvSpPr txBox="1"/>
          <p:nvPr/>
        </p:nvSpPr>
        <p:spPr>
          <a:xfrm rot="18997007">
            <a:off x="3231871" y="2764210"/>
            <a:ext cx="10823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gCl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50D63E4-82A3-154B-96E1-5022A3D93C32}"/>
              </a:ext>
            </a:extLst>
          </p:cNvPr>
          <p:cNvSpPr txBox="1"/>
          <p:nvPr/>
        </p:nvSpPr>
        <p:spPr>
          <a:xfrm rot="18997007">
            <a:off x="3954873" y="2627679"/>
            <a:ext cx="1479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NH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O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99F16B-C4A8-134F-B6FA-69E388C563C3}"/>
              </a:ext>
            </a:extLst>
          </p:cNvPr>
          <p:cNvSpPr txBox="1"/>
          <p:nvPr/>
        </p:nvSpPr>
        <p:spPr>
          <a:xfrm rot="18997007">
            <a:off x="3646177" y="2764210"/>
            <a:ext cx="10823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nCl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586632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6</TotalTime>
  <Words>39</Words>
  <Application>Microsoft Macintosh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用户</dc:creator>
  <cp:lastModifiedBy>Microsoft Office 用户</cp:lastModifiedBy>
  <cp:revision>66</cp:revision>
  <cp:lastPrinted>2020-02-19T01:41:33Z</cp:lastPrinted>
  <dcterms:created xsi:type="dcterms:W3CDTF">2020-02-05T03:48:30Z</dcterms:created>
  <dcterms:modified xsi:type="dcterms:W3CDTF">2020-03-21T01:19:36Z</dcterms:modified>
</cp:coreProperties>
</file>